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91" r:id="rId2"/>
    <p:sldId id="292" r:id="rId3"/>
    <p:sldId id="287" r:id="rId4"/>
    <p:sldId id="257" r:id="rId5"/>
    <p:sldId id="285" r:id="rId6"/>
    <p:sldId id="259" r:id="rId7"/>
    <p:sldId id="294" r:id="rId8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1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14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3172" tIns="46586" rIns="93172" bIns="46586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3172" tIns="46586" rIns="93172" bIns="46586" rtlCol="0"/>
          <a:lstStyle>
            <a:lvl1pPr algn="r">
              <a:defRPr sz="1300"/>
            </a:lvl1pPr>
          </a:lstStyle>
          <a:p>
            <a:fld id="{CA9C9E3A-F621-441F-A5AF-73566FC7FD19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2" tIns="46586" rIns="93172" bIns="4658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2" tIns="46586" rIns="93172" bIns="46586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2" tIns="46586" rIns="93172" bIns="46586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2" tIns="46586" rIns="93172" bIns="46586" rtlCol="0" anchor="b"/>
          <a:lstStyle>
            <a:lvl1pPr algn="r">
              <a:defRPr sz="1300"/>
            </a:lvl1pPr>
          </a:lstStyle>
          <a:p>
            <a:fld id="{1AB9FD2E-0B6B-4E19-BCA1-020ADEAE7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0783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812800" y="1220788"/>
            <a:ext cx="5853113" cy="329406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B666AB7-C3E3-4D5D-934D-EE0C3B55A76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7663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812800" y="1220788"/>
            <a:ext cx="5853113" cy="329406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84919">
              <a:defRPr/>
            </a:pPr>
            <a:r>
              <a:rPr lang="en-US" dirty="0" smtClean="0"/>
              <a:t>The node degree</a:t>
            </a:r>
            <a:r>
              <a:rPr lang="en-US" baseline="0" dirty="0" smtClean="0"/>
              <a:t> of the progression related protein network (n=107) follows a power low distribution:  y=</a:t>
            </a:r>
            <a:r>
              <a:rPr lang="en-US" baseline="0" dirty="0" err="1" smtClean="0"/>
              <a:t>aX^b</a:t>
            </a:r>
            <a:r>
              <a:rPr lang="en-US" baseline="0" dirty="0" smtClean="0"/>
              <a:t> </a:t>
            </a:r>
            <a:r>
              <a:rPr lang="en-US" baseline="0" dirty="0" err="1" smtClean="0"/>
              <a:t>whre</a:t>
            </a:r>
            <a:r>
              <a:rPr lang="en-US" baseline="0" dirty="0" smtClean="0"/>
              <a:t> a=</a:t>
            </a:r>
            <a:r>
              <a:rPr lang="en-US" dirty="0" smtClean="0"/>
              <a:t>9.217</a:t>
            </a:r>
            <a:r>
              <a:rPr lang="en-US" baseline="0" dirty="0" smtClean="0"/>
              <a:t>and b=</a:t>
            </a:r>
            <a:r>
              <a:rPr lang="en-US" dirty="0" smtClean="0"/>
              <a:t>-0.894</a:t>
            </a:r>
            <a:r>
              <a:rPr lang="en-US" baseline="0" dirty="0" smtClean="0"/>
              <a:t> with a correlation </a:t>
            </a:r>
            <a:r>
              <a:rPr lang="en-US" dirty="0" smtClean="0"/>
              <a:t>0.779</a:t>
            </a:r>
            <a:r>
              <a:rPr lang="en-US" baseline="0" dirty="0" smtClean="0"/>
              <a:t>, R-squared: </a:t>
            </a:r>
            <a:r>
              <a:rPr lang="en-US" dirty="0" smtClean="0"/>
              <a:t>0.690</a:t>
            </a:r>
          </a:p>
          <a:p>
            <a:endParaRPr lang="en-US" dirty="0" smtClean="0"/>
          </a:p>
          <a:p>
            <a:r>
              <a:rPr lang="en-US" dirty="0" smtClean="0"/>
              <a:t>9.217</a:t>
            </a:r>
          </a:p>
          <a:p>
            <a:r>
              <a:rPr lang="en-US" dirty="0" smtClean="0"/>
              <a:t>-0.894</a:t>
            </a:r>
          </a:p>
          <a:p>
            <a:r>
              <a:rPr lang="en-US" dirty="0" smtClean="0"/>
              <a:t>0.779</a:t>
            </a:r>
          </a:p>
          <a:p>
            <a:r>
              <a:rPr lang="en-US" dirty="0" smtClean="0"/>
              <a:t>0.690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B666AB7-C3E3-4D5D-934D-EE0C3B55A76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9229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041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57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573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679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87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151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102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235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372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010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351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A84950-980C-4535-B6EA-76C4AB6D8C25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3A30F-227A-4FA2-8F98-CB6D0A94C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747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474022" y="6336977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1</a:t>
            </a:r>
            <a:endParaRPr lang="en-US" dirty="0"/>
          </a:p>
        </p:txBody>
      </p:sp>
      <p:grpSp>
        <p:nvGrpSpPr>
          <p:cNvPr id="29" name="Group 28"/>
          <p:cNvGrpSpPr/>
          <p:nvPr/>
        </p:nvGrpSpPr>
        <p:grpSpPr>
          <a:xfrm>
            <a:off x="1924216" y="834228"/>
            <a:ext cx="8391879" cy="5450044"/>
            <a:chOff x="1924216" y="834228"/>
            <a:chExt cx="8391879" cy="5450044"/>
          </a:xfrm>
        </p:grpSpPr>
        <p:cxnSp>
          <p:nvCxnSpPr>
            <p:cNvPr id="2" name="Straight Arrow Connector 1"/>
            <p:cNvCxnSpPr/>
            <p:nvPr/>
          </p:nvCxnSpPr>
          <p:spPr>
            <a:xfrm>
              <a:off x="3825648" y="3428915"/>
              <a:ext cx="0" cy="1330635"/>
            </a:xfrm>
            <a:prstGeom prst="straightConnector1">
              <a:avLst/>
            </a:prstGeom>
            <a:ln w="28575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" name="Picture 10" descr="Image result for igg iga column fraction mass spectrometry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90" t="12430" r="84742" b="72754"/>
            <a:stretch/>
          </p:blipFill>
          <p:spPr bwMode="auto">
            <a:xfrm>
              <a:off x="3655482" y="2627375"/>
              <a:ext cx="297768" cy="636966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>
              <a:off x="3281983" y="1156873"/>
              <a:ext cx="109305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ge 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II, III TNBC </a:t>
              </a: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/>
            <a:srcRect l="37753" t="13654" r="40914" b="28271"/>
            <a:stretch/>
          </p:blipFill>
          <p:spPr>
            <a:xfrm flipH="1">
              <a:off x="3737869" y="2027217"/>
              <a:ext cx="161736" cy="482347"/>
            </a:xfrm>
            <a:prstGeom prst="rect">
              <a:avLst/>
            </a:prstGeom>
          </p:spPr>
        </p:pic>
        <p:pic>
          <p:nvPicPr>
            <p:cNvPr id="7" name="Picture 2" descr="https://s2.yimg.com/bt/api/res/1.2/lq1FtNoA9q.TEVoMwzxGAw--/YXBwaWQ9eW5ld3NfbGVnbztxPTg1O3c9MTczMg--/http:/media.zenfs.com/en/homerun/feed_manager_auto_publish_494/72777e42e60f3edbfd0dab335440be08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975" t="36683" r="7098" b="8273"/>
            <a:stretch/>
          </p:blipFill>
          <p:spPr bwMode="auto">
            <a:xfrm>
              <a:off x="3872995" y="1551570"/>
              <a:ext cx="188477" cy="400151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2" descr="https://s2.yimg.com/bt/api/res/1.2/lq1FtNoA9q.TEVoMwzxGAw--/YXBwaWQ9eW5ld3NfbGVnbztxPTg1O3c9MTczMg--/http:/media.zenfs.com/en/homerun/feed_manager_auto_publish_494/72777e42e60f3edbfd0dab335440be08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975" t="36683" r="7098" b="8273"/>
            <a:stretch/>
          </p:blipFill>
          <p:spPr bwMode="auto">
            <a:xfrm>
              <a:off x="3710413" y="1554526"/>
              <a:ext cx="188477" cy="400151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2" descr="https://s2.yimg.com/bt/api/res/1.2/lq1FtNoA9q.TEVoMwzxGAw--/YXBwaWQ9eW5ld3NfbGVnbztxPTg1O3c9MTczMg--/http:/media.zenfs.com/en/homerun/feed_manager_auto_publish_494/72777e42e60f3edbfd0dab335440be08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975" t="36683" r="7098" b="8273"/>
            <a:stretch/>
          </p:blipFill>
          <p:spPr bwMode="auto">
            <a:xfrm>
              <a:off x="3553236" y="1556412"/>
              <a:ext cx="188477" cy="400151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0" name="Straight Arrow Connector 9"/>
            <p:cNvCxnSpPr/>
            <p:nvPr/>
          </p:nvCxnSpPr>
          <p:spPr>
            <a:xfrm flipV="1">
              <a:off x="4816453" y="2967644"/>
              <a:ext cx="969205" cy="116090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1" name="Picture 6" descr="Image result for 2d hplc fraction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23" t="9821"/>
            <a:stretch/>
          </p:blipFill>
          <p:spPr bwMode="auto">
            <a:xfrm>
              <a:off x="4024300" y="4967215"/>
              <a:ext cx="406345" cy="384998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>
              <a:off x="4382771" y="5064415"/>
              <a:ext cx="1694593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dentify differential expression proteins between progressor vs non-progressor</a:t>
              </a:r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>
              <a:off x="3928219" y="5573222"/>
              <a:ext cx="378198" cy="0"/>
            </a:xfrm>
            <a:prstGeom prst="straightConnector1">
              <a:avLst/>
            </a:prstGeom>
            <a:ln w="28575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6525962" y="3488810"/>
              <a:ext cx="1428626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tegrate mice plasma and human TNBC cell lines data to refine signatures </a:t>
              </a: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>
              <a:off x="8011126" y="2903315"/>
              <a:ext cx="0" cy="1856236"/>
            </a:xfrm>
            <a:prstGeom prst="straightConnector1">
              <a:avLst/>
            </a:prstGeom>
            <a:ln w="28575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2756144" y="2815055"/>
              <a:ext cx="92573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-plex TMT labeling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662213" y="4005641"/>
              <a:ext cx="110689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-D HPLC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ractionatio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924216" y="5188874"/>
              <a:ext cx="169406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96 fractions analyzed with LC-HDMS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cxnSp>
          <p:nvCxnSpPr>
            <p:cNvPr id="19" name="Elbow Connector 18"/>
            <p:cNvCxnSpPr/>
            <p:nvPr/>
          </p:nvCxnSpPr>
          <p:spPr>
            <a:xfrm rot="5400000">
              <a:off x="3207829" y="3798002"/>
              <a:ext cx="102407" cy="1"/>
            </a:xfrm>
            <a:prstGeom prst="bentConnector3">
              <a:avLst>
                <a:gd name="adj1" fmla="val -185739"/>
              </a:avLst>
            </a:prstGeom>
            <a:ln w="19050">
              <a:solidFill>
                <a:schemeClr val="accent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Elbow Connector 19"/>
            <p:cNvCxnSpPr/>
            <p:nvPr/>
          </p:nvCxnSpPr>
          <p:spPr>
            <a:xfrm rot="16200000" flipH="1">
              <a:off x="3130614" y="4715861"/>
              <a:ext cx="264776" cy="1"/>
            </a:xfrm>
            <a:prstGeom prst="bentConnector3">
              <a:avLst>
                <a:gd name="adj1" fmla="val -17392"/>
              </a:avLst>
            </a:prstGeom>
            <a:ln w="19050">
              <a:solidFill>
                <a:schemeClr val="accent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8532597" y="5082225"/>
              <a:ext cx="1783498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valuate prognostic value of candidate proteins on independent human cohorts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 rot="18602462">
              <a:off x="3997448" y="3184521"/>
              <a:ext cx="2128272" cy="461665"/>
            </a:xfrm>
            <a:prstGeom prst="rect">
              <a:avLst/>
            </a:prstGeom>
            <a:ln w="28575">
              <a:noFill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erive progression- related protein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etwork </a:t>
              </a:r>
            </a:p>
          </p:txBody>
        </p:sp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124203" y="3042108"/>
              <a:ext cx="1934716" cy="1333709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85" t="15298" r="16578" b="7445"/>
            <a:stretch/>
          </p:blipFill>
          <p:spPr>
            <a:xfrm>
              <a:off x="6058321" y="834228"/>
              <a:ext cx="3509628" cy="1710851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>
              <a:off x="7742015" y="2531337"/>
              <a:ext cx="849928" cy="283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GF</a:t>
              </a:r>
              <a:r>
                <a:rPr lang="el-GR" sz="1200" dirty="0"/>
                <a:t>β</a:t>
              </a:r>
              <a:endParaRPr lang="en-US" sz="1200" dirty="0"/>
            </a:p>
          </p:txBody>
        </p:sp>
        <p:sp>
          <p:nvSpPr>
            <p:cNvPr id="28" name="Oval 27"/>
            <p:cNvSpPr/>
            <p:nvPr/>
          </p:nvSpPr>
          <p:spPr>
            <a:xfrm>
              <a:off x="7936530" y="2397738"/>
              <a:ext cx="131807" cy="112991"/>
            </a:xfrm>
            <a:prstGeom prst="ellipse">
              <a:avLst/>
            </a:prstGeom>
            <a:solidFill>
              <a:srgbClr val="FFC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493260" y="4872846"/>
              <a:ext cx="1961139" cy="1411426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9"/>
            <a:srcRect l="31602" t="46718" r="49665" b="1"/>
            <a:stretch/>
          </p:blipFill>
          <p:spPr>
            <a:xfrm rot="16200000">
              <a:off x="4769863" y="3948278"/>
              <a:ext cx="900516" cy="1426244"/>
            </a:xfrm>
            <a:prstGeom prst="rect">
              <a:avLst/>
            </a:prstGeom>
          </p:spPr>
        </p:pic>
      </p:grpSp>
      <p:pic>
        <p:nvPicPr>
          <p:cNvPr id="31" name="Picture 6" descr="Image result for 2d hplc fraction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23" t="9821"/>
          <a:stretch/>
        </p:blipFill>
        <p:spPr bwMode="auto">
          <a:xfrm>
            <a:off x="3506537" y="5208606"/>
            <a:ext cx="489523" cy="4638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Rectangle 31"/>
          <p:cNvSpPr/>
          <p:nvPr/>
        </p:nvSpPr>
        <p:spPr>
          <a:xfrm>
            <a:off x="4024300" y="4872846"/>
            <a:ext cx="406345" cy="4793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668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11550" r="34440" b="45326"/>
          <a:stretch/>
        </p:blipFill>
        <p:spPr>
          <a:xfrm>
            <a:off x="2654510" y="2479589"/>
            <a:ext cx="4281750" cy="114506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483707" y="2141035"/>
            <a:ext cx="14285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. Blood collec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662616" y="2141034"/>
            <a:ext cx="10118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. Follow u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676767" y="2171812"/>
            <a:ext cx="18737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. Assign outcome grou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936260" y="2645487"/>
            <a:ext cx="18501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tastasize detected: 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936260" y="3192733"/>
            <a:ext cx="23952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o metastasize detected: non-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483707" y="4086081"/>
            <a:ext cx="155568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hort 1: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-matched TNBC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tage II</a:t>
            </a:r>
          </a:p>
          <a:p>
            <a:pPr algn="ctr"/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menopaus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181585" y="4086081"/>
            <a:ext cx="155568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hort 2: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-matched TNBC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tage II</a:t>
            </a:r>
          </a:p>
          <a:p>
            <a:pPr algn="ctr"/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stmenopaus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813558" y="4086081"/>
            <a:ext cx="155568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hort 3: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-matched TNBC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tage III</a:t>
            </a:r>
          </a:p>
          <a:p>
            <a:pPr algn="ctr"/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menopaus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521822" y="4086081"/>
            <a:ext cx="155568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hort 4: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e-matched TNBC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tage III</a:t>
            </a:r>
          </a:p>
          <a:p>
            <a:pPr algn="ctr"/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stmenopaus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795385" y="5697883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75499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7811" y="887296"/>
            <a:ext cx="6218595" cy="447101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987328" y="628277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212430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416" t="6246" r="3387" b="55612"/>
          <a:stretch/>
        </p:blipFill>
        <p:spPr>
          <a:xfrm>
            <a:off x="2277528" y="2917767"/>
            <a:ext cx="8859049" cy="197005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773144" y="5714358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719912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90" b="4537"/>
          <a:stretch/>
        </p:blipFill>
        <p:spPr>
          <a:xfrm>
            <a:off x="276562" y="2042984"/>
            <a:ext cx="11758919" cy="267729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022024" y="5607267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3574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5068" y="1609460"/>
            <a:ext cx="3227703" cy="384663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102657" y="5961494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60368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Oval 5"/>
          <p:cNvSpPr/>
          <p:nvPr/>
        </p:nvSpPr>
        <p:spPr>
          <a:xfrm>
            <a:off x="2857836" y="2141838"/>
            <a:ext cx="6492803" cy="4229377"/>
          </a:xfrm>
          <a:prstGeom prst="ellipse">
            <a:avLst/>
          </a:prstGeom>
          <a:solidFill>
            <a:srgbClr val="FEF8F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/>
          <p:cNvSpPr/>
          <p:nvPr/>
        </p:nvSpPr>
        <p:spPr>
          <a:xfrm>
            <a:off x="3627499" y="3017731"/>
            <a:ext cx="5009322" cy="3377657"/>
          </a:xfrm>
          <a:prstGeom prst="ellipse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9" name="Oval 8"/>
          <p:cNvSpPr/>
          <p:nvPr/>
        </p:nvSpPr>
        <p:spPr>
          <a:xfrm>
            <a:off x="3888475" y="3772786"/>
            <a:ext cx="4460681" cy="259842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10" name="Oval 9"/>
          <p:cNvSpPr/>
          <p:nvPr/>
        </p:nvSpPr>
        <p:spPr>
          <a:xfrm>
            <a:off x="4230381" y="4472500"/>
            <a:ext cx="3760967" cy="1898715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11" name="Oval 10"/>
          <p:cNvSpPr/>
          <p:nvPr/>
        </p:nvSpPr>
        <p:spPr>
          <a:xfrm>
            <a:off x="4643848" y="5243777"/>
            <a:ext cx="2918129" cy="1127438"/>
          </a:xfrm>
          <a:prstGeom prst="ellipse">
            <a:avLst/>
          </a:prstGeom>
          <a:solidFill>
            <a:srgbClr val="ED7E33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12" name="Oval 11"/>
          <p:cNvSpPr/>
          <p:nvPr/>
        </p:nvSpPr>
        <p:spPr>
          <a:xfrm>
            <a:off x="5085145" y="5663549"/>
            <a:ext cx="2067340" cy="707666"/>
          </a:xfrm>
          <a:prstGeom prst="ellipse">
            <a:avLst/>
          </a:prstGeom>
          <a:solidFill>
            <a:srgbClr val="DA6414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13" name="Oval 12"/>
          <p:cNvSpPr/>
          <p:nvPr/>
        </p:nvSpPr>
        <p:spPr>
          <a:xfrm>
            <a:off x="2158314" y="1070918"/>
            <a:ext cx="8048367" cy="5300295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5062275" y="1485146"/>
            <a:ext cx="21130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teins detected with TMT quantitation in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asma from 4 TNBC cohorts (n=1,618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112951" y="2487255"/>
            <a:ext cx="20152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teins robustly quantified in plasma at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ast 3 out of 4 TNBC cohorts (n=347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826121" y="3299523"/>
            <a:ext cx="2632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ially expressed proteins between M vs non M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th FC &gt; 1.25 in at least 3 out of 4 cohorts (n=97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866269" y="4010833"/>
            <a:ext cx="26324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ially expressed proteins between M vs non M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th both FC &gt; 1.25 and paired t-test </a:t>
            </a:r>
          </a:p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&lt;0.1 from 4 cohorts (n=43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258204" y="4722228"/>
            <a:ext cx="18485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tein show concordant change in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uman and mice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gressors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n=13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038155" y="5311277"/>
            <a:ext cx="2254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gression-related proteins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verlapped with human TNBC cell lines (n=9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407349" y="5868740"/>
            <a:ext cx="15087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gression-related proteins </a:t>
            </a:r>
          </a:p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igher in M (n=3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190579" y="6488668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2234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60</TotalTime>
  <Words>281</Words>
  <Application>Microsoft Office PowerPoint</Application>
  <PresentationFormat>Widescreen</PresentationFormat>
  <Paragraphs>60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sou,Peiling</dc:creator>
  <cp:lastModifiedBy>Katayama,Hiroyuki</cp:lastModifiedBy>
  <cp:revision>74</cp:revision>
  <cp:lastPrinted>2018-09-05T16:48:33Z</cp:lastPrinted>
  <dcterms:created xsi:type="dcterms:W3CDTF">2017-07-11T19:24:03Z</dcterms:created>
  <dcterms:modified xsi:type="dcterms:W3CDTF">2019-02-12T01:18:03Z</dcterms:modified>
</cp:coreProperties>
</file>